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  <p:sldId id="259" r:id="rId5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4995" autoAdjust="0"/>
    <p:restoredTop sz="94660"/>
  </p:normalViewPr>
  <p:slideViewPr>
    <p:cSldViewPr snapToGrid="0" showGuides="1">
      <p:cViewPr varScale="1">
        <p:scale>
          <a:sx n="105" d="100"/>
          <a:sy n="105" d="100"/>
        </p:scale>
        <p:origin x="138" y="186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EEF098B5-FFDD-45A5-AAA3-1675172F6201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>
            <a:extLst>
              <a:ext uri="{FF2B5EF4-FFF2-40B4-BE49-F238E27FC236}">
                <a16:creationId xmlns:a16="http://schemas.microsoft.com/office/drawing/2014/main" xmlns="" id="{0077F990-3383-40A0-8F61-53E9507433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子標題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13A35804-BED4-40A4-9703-338C24558AD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83FE0404-77CB-4BB7-93E0-0B1D0B3258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84B9BCDE-D897-4EA0-AAB5-7BBECB802D9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6740219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2DE0A08A-0555-4B51-9EA8-B0A4E20EE70F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6817A7B9-3BA7-4281-AF8B-5E0ECDED767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E8F3CCE8-7044-49EA-AB5F-6267A1712BE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B1E0BCEB-9C6A-4BE3-893B-2F37F919525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B2BD128E-931C-48DA-8B78-2655E5111B0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1628118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>
            <a:extLst>
              <a:ext uri="{FF2B5EF4-FFF2-40B4-BE49-F238E27FC236}">
                <a16:creationId xmlns:a16="http://schemas.microsoft.com/office/drawing/2014/main" xmlns="" id="{D819034E-C91E-48D8-AAF8-D72999A66D5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>
            <a:extLst>
              <a:ext uri="{FF2B5EF4-FFF2-40B4-BE49-F238E27FC236}">
                <a16:creationId xmlns:a16="http://schemas.microsoft.com/office/drawing/2014/main" xmlns="" id="{0A550775-351A-45D8-9F63-B468B6C38B7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CF4746E9-399B-43E9-8EFD-EEA079B2F2E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4502B22F-06F8-4D47-90B0-625AD0CD650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37FD6578-76C6-4266-B45B-43DD2E186A6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32504657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E90B0A5B-FD73-4E5B-889B-EC6DD4A48E1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DBB879BB-9BE2-4832-8355-C5845B61696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C06B7C6F-EF82-4B8E-B191-BC10D4E9BF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BE5E6919-9D29-4061-BA47-3C87E1DF13D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C24D938A-D859-4BD4-8CF5-7B0811F2F1B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40356299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EFF6B42D-95DF-4754-9232-34CBE5826FC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AA505D1D-68E6-42A9-8C36-22FA711448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5335C68E-5135-474A-9B02-248510E5043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2FF55102-6B53-497B-AAD0-7D8B1300F9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508970E4-066C-4CB2-A03D-45E58E6FBB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61046108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個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2945E074-7719-41BC-A8A7-401B2059F5E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EE76605F-B9CA-4D43-BADA-2580A552AA8C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F16DB0F3-1DE5-4C0C-A019-B3726EBB8281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04A12F1A-1C87-43B3-89F2-211A98E35C7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1DC8DF12-DF6C-430C-B346-07870441C0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DEAC45EE-F90D-48E2-875D-1837A5FC11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01411081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20F8BF96-ADB5-4E67-8F12-604BEE4E637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A0D6F228-2BE6-4384-AEED-13AD163C1338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>
            <a:extLst>
              <a:ext uri="{FF2B5EF4-FFF2-40B4-BE49-F238E27FC236}">
                <a16:creationId xmlns:a16="http://schemas.microsoft.com/office/drawing/2014/main" xmlns="" id="{A1A18AAC-259F-4E51-8B10-B3ADD3A5709D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>
            <a:extLst>
              <a:ext uri="{FF2B5EF4-FFF2-40B4-BE49-F238E27FC236}">
                <a16:creationId xmlns:a16="http://schemas.microsoft.com/office/drawing/2014/main" xmlns="" id="{9FDA1CEE-2132-4A7C-926E-7D2F85EE66A4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>
            <a:extLst>
              <a:ext uri="{FF2B5EF4-FFF2-40B4-BE49-F238E27FC236}">
                <a16:creationId xmlns:a16="http://schemas.microsoft.com/office/drawing/2014/main" xmlns="" id="{135C0A39-8C69-4885-8A3E-88647A4416B5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>
            <a:extLst>
              <a:ext uri="{FF2B5EF4-FFF2-40B4-BE49-F238E27FC236}">
                <a16:creationId xmlns:a16="http://schemas.microsoft.com/office/drawing/2014/main" xmlns="" id="{B486A19B-420E-409D-8953-1B5C4BE6DAE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8" name="頁尾版面配置區 7">
            <a:extLst>
              <a:ext uri="{FF2B5EF4-FFF2-40B4-BE49-F238E27FC236}">
                <a16:creationId xmlns:a16="http://schemas.microsoft.com/office/drawing/2014/main" xmlns="" id="{FE689323-BB48-4E7B-8D0E-A8F8FACAD2B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>
            <a:extLst>
              <a:ext uri="{FF2B5EF4-FFF2-40B4-BE49-F238E27FC236}">
                <a16:creationId xmlns:a16="http://schemas.microsoft.com/office/drawing/2014/main" xmlns="" id="{4213E4F1-ABAD-4A15-BC1A-4109A265D93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93034104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83C95065-1679-48E1-AE84-68E53A490B7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>
            <a:extLst>
              <a:ext uri="{FF2B5EF4-FFF2-40B4-BE49-F238E27FC236}">
                <a16:creationId xmlns:a16="http://schemas.microsoft.com/office/drawing/2014/main" xmlns="" id="{8429CA5E-CF6F-43D3-9D60-928CA86651D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4" name="頁尾版面配置區 3">
            <a:extLst>
              <a:ext uri="{FF2B5EF4-FFF2-40B4-BE49-F238E27FC236}">
                <a16:creationId xmlns:a16="http://schemas.microsoft.com/office/drawing/2014/main" xmlns="" id="{A11DC662-6A76-40CD-8910-76D490A59CF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>
            <a:extLst>
              <a:ext uri="{FF2B5EF4-FFF2-40B4-BE49-F238E27FC236}">
                <a16:creationId xmlns:a16="http://schemas.microsoft.com/office/drawing/2014/main" xmlns="" id="{5FF9D2ED-53A4-45CA-A1CA-0D4B470AA05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067802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>
            <a:extLst>
              <a:ext uri="{FF2B5EF4-FFF2-40B4-BE49-F238E27FC236}">
                <a16:creationId xmlns:a16="http://schemas.microsoft.com/office/drawing/2014/main" xmlns="" id="{812BF981-F6CB-4982-8C2F-42C38AE04C3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3" name="頁尾版面配置區 2">
            <a:extLst>
              <a:ext uri="{FF2B5EF4-FFF2-40B4-BE49-F238E27FC236}">
                <a16:creationId xmlns:a16="http://schemas.microsoft.com/office/drawing/2014/main" xmlns="" id="{24E9C4BA-88A8-4C31-AA8F-D63A1655D8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>
            <a:extLst>
              <a:ext uri="{FF2B5EF4-FFF2-40B4-BE49-F238E27FC236}">
                <a16:creationId xmlns:a16="http://schemas.microsoft.com/office/drawing/2014/main" xmlns="" id="{C5E55B7B-BBAC-41EC-B740-F9D409501BB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6285216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輔助字幕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1834894C-20D0-4B90-8676-3ECE736C228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>
            <a:extLst>
              <a:ext uri="{FF2B5EF4-FFF2-40B4-BE49-F238E27FC236}">
                <a16:creationId xmlns:a16="http://schemas.microsoft.com/office/drawing/2014/main" xmlns="" id="{8206F11F-9545-4506-82FF-17520C2DE53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AE0E2C20-26F3-4A6A-B8D7-C1A17BCC4EF9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6B2BE418-B928-4E56-A0AB-DE15DA5D5F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E87F4DCD-567B-4D72-8750-27BE76A92EF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BBEEBCA2-4E2A-4ED6-AF99-34F35BA462A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88454368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輔助字幕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A143C197-BDB3-4DC8-A900-BE5FA1ED087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>
            <a:extLst>
              <a:ext uri="{FF2B5EF4-FFF2-40B4-BE49-F238E27FC236}">
                <a16:creationId xmlns:a16="http://schemas.microsoft.com/office/drawing/2014/main" xmlns="" id="{D5104822-6A80-4D2D-B5EF-00DD2351D5C0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>
            <a:extLst>
              <a:ext uri="{FF2B5EF4-FFF2-40B4-BE49-F238E27FC236}">
                <a16:creationId xmlns:a16="http://schemas.microsoft.com/office/drawing/2014/main" xmlns="" id="{6C78E315-A1BF-4C2D-A5F7-95D3C49D9C83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>
            <a:extLst>
              <a:ext uri="{FF2B5EF4-FFF2-40B4-BE49-F238E27FC236}">
                <a16:creationId xmlns:a16="http://schemas.microsoft.com/office/drawing/2014/main" xmlns="" id="{79685A81-3E63-48D7-9B6C-7518F2B5CC7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6" name="頁尾版面配置區 5">
            <a:extLst>
              <a:ext uri="{FF2B5EF4-FFF2-40B4-BE49-F238E27FC236}">
                <a16:creationId xmlns:a16="http://schemas.microsoft.com/office/drawing/2014/main" xmlns="" id="{E7FDA058-5E8B-412F-93AC-ADCD4ADC766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>
            <a:extLst>
              <a:ext uri="{FF2B5EF4-FFF2-40B4-BE49-F238E27FC236}">
                <a16:creationId xmlns:a16="http://schemas.microsoft.com/office/drawing/2014/main" xmlns="" id="{BDC22B06-C889-43E3-AA00-03F33C1C68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87368097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>
            <a:extLst>
              <a:ext uri="{FF2B5EF4-FFF2-40B4-BE49-F238E27FC236}">
                <a16:creationId xmlns:a16="http://schemas.microsoft.com/office/drawing/2014/main" xmlns="" id="{45399FA0-4038-4ACB-98C8-75BBA48B15E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>
            <a:extLst>
              <a:ext uri="{FF2B5EF4-FFF2-40B4-BE49-F238E27FC236}">
                <a16:creationId xmlns:a16="http://schemas.microsoft.com/office/drawing/2014/main" xmlns="" id="{C51D842E-B4CF-4E10-BA67-9AA29597BBF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>
            <a:extLst>
              <a:ext uri="{FF2B5EF4-FFF2-40B4-BE49-F238E27FC236}">
                <a16:creationId xmlns:a16="http://schemas.microsoft.com/office/drawing/2014/main" xmlns="" id="{B0E34F18-87B6-4BCD-AFF7-AF89F2D993F5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EF06BCC-4210-41B7-8CFD-B850547A68FE}" type="datetimeFigureOut">
              <a:rPr lang="zh-TW" altLang="en-US" smtClean="0"/>
              <a:t>2022/2/11</a:t>
            </a:fld>
            <a:endParaRPr lang="zh-TW" altLang="en-US"/>
          </a:p>
        </p:txBody>
      </p:sp>
      <p:sp>
        <p:nvSpPr>
          <p:cNvPr id="5" name="頁尾版面配置區 4">
            <a:extLst>
              <a:ext uri="{FF2B5EF4-FFF2-40B4-BE49-F238E27FC236}">
                <a16:creationId xmlns:a16="http://schemas.microsoft.com/office/drawing/2014/main" xmlns="" id="{54A3A938-3A23-43F7-BE48-BAD17CF5F787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>
            <a:extLst>
              <a:ext uri="{FF2B5EF4-FFF2-40B4-BE49-F238E27FC236}">
                <a16:creationId xmlns:a16="http://schemas.microsoft.com/office/drawing/2014/main" xmlns="" id="{2B96BA0D-F85C-4812-957E-4F0CF394D4BD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1E16BD0-60ED-41EF-8F0A-73F9FBEF9F70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20101638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矩形 3"/>
          <p:cNvSpPr/>
          <p:nvPr/>
        </p:nvSpPr>
        <p:spPr>
          <a:xfrm>
            <a:off x="1149259" y="1351978"/>
            <a:ext cx="10061285" cy="452431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altLang="zh-TW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WAS </a:t>
            </a:r>
            <a:r>
              <a:rPr lang="en-US" altLang="zh-TW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data have shown these </a:t>
            </a:r>
            <a:r>
              <a:rPr lang="en-US" altLang="zh-TW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</a:t>
            </a:r>
            <a:r>
              <a:rPr lang="en-US" altLang="zh-TW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s are highly associated with </a:t>
            </a:r>
            <a:r>
              <a:rPr lang="en-US" altLang="zh-TW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hyperthyroidism </a:t>
            </a:r>
            <a:r>
              <a:rPr lang="en-US" altLang="zh-TW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atients . We used Linkage disequilibrium to calculate the association of these </a:t>
            </a:r>
            <a:r>
              <a:rPr lang="en-US" altLang="zh-TW" sz="3600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candidate </a:t>
            </a:r>
            <a:r>
              <a:rPr lang="en-US" altLang="zh-TW" sz="36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SNPs near the most significant loci. We proved the associations with allelic variants of these new loci in linkage disequilibrium were shown to be stronger than previously observed associations</a:t>
            </a:r>
            <a:endParaRPr lang="zh-TW" altLang="en-US" sz="36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88321279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DA26BF48-8EFA-4CDA-95EE-8DA97033225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HLA</a:t>
            </a:r>
            <a:endParaRPr lang="zh-TW" altLang="en-US" dirty="0"/>
          </a:p>
        </p:txBody>
      </p:sp>
      <p:pic>
        <p:nvPicPr>
          <p:cNvPr id="9" name="圖片 8">
            <a:extLst>
              <a:ext uri="{FF2B5EF4-FFF2-40B4-BE49-F238E27FC236}">
                <a16:creationId xmlns:a16="http://schemas.microsoft.com/office/drawing/2014/main" xmlns="" id="{5A434C16-71F4-4CD8-AC6A-71CC82DAE03A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34160"/>
            <a:ext cx="12192000" cy="5323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565716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099A6345-80DA-46F4-A509-C4D889ED2F8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GTLA4</a:t>
            </a:r>
            <a:endParaRPr lang="zh-TW" altLang="en-US" dirty="0"/>
          </a:p>
        </p:txBody>
      </p:sp>
      <p:pic>
        <p:nvPicPr>
          <p:cNvPr id="5" name="圖片 4">
            <a:extLst>
              <a:ext uri="{FF2B5EF4-FFF2-40B4-BE49-F238E27FC236}">
                <a16:creationId xmlns:a16="http://schemas.microsoft.com/office/drawing/2014/main" xmlns="" id="{C2C6B6A6-5AF9-41DC-9286-9C1AB34F2C03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34160"/>
            <a:ext cx="12192000" cy="5323840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884379514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>
            <a:extLst>
              <a:ext uri="{FF2B5EF4-FFF2-40B4-BE49-F238E27FC236}">
                <a16:creationId xmlns:a16="http://schemas.microsoft.com/office/drawing/2014/main" xmlns="" id="{60726905-98CF-4FCF-9A9B-A770E1D7085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altLang="zh-TW" dirty="0"/>
              <a:t>TSHR</a:t>
            </a:r>
            <a:endParaRPr lang="zh-TW" altLang="en-US" dirty="0"/>
          </a:p>
        </p:txBody>
      </p:sp>
      <p:pic>
        <p:nvPicPr>
          <p:cNvPr id="5" name="內容版面配置區 4">
            <a:extLst>
              <a:ext uri="{FF2B5EF4-FFF2-40B4-BE49-F238E27FC236}">
                <a16:creationId xmlns:a16="http://schemas.microsoft.com/office/drawing/2014/main" xmlns="" id="{DD96ACEA-D141-4268-A88D-1926240CB825}"/>
              </a:ext>
            </a:extLst>
          </p:cNvPr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1534160"/>
            <a:ext cx="12192000" cy="5323840"/>
          </a:xfrm>
        </p:spPr>
      </p:pic>
    </p:spTree>
    <p:extLst>
      <p:ext uri="{BB962C8B-B14F-4D97-AF65-F5344CB8AC3E}">
        <p14:creationId xmlns:p14="http://schemas.microsoft.com/office/powerpoint/2010/main" val="215098741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6</TotalTime>
  <Words>58</Words>
  <Application>Microsoft Office PowerPoint</Application>
  <PresentationFormat>寬螢幕</PresentationFormat>
  <Paragraphs>4</Paragraphs>
  <Slides>4</Slides>
  <Notes>0</Notes>
  <HiddenSlides>0</HiddenSlides>
  <MMClips>0</MMClips>
  <ScaleCrop>false</ScaleCrop>
  <HeadingPairs>
    <vt:vector size="6" baseType="variant">
      <vt:variant>
        <vt:lpstr>使用字型</vt:lpstr>
      </vt:variant>
      <vt:variant>
        <vt:i4>5</vt:i4>
      </vt:variant>
      <vt:variant>
        <vt:lpstr>佈景主題</vt:lpstr>
      </vt:variant>
      <vt:variant>
        <vt:i4>1</vt:i4>
      </vt:variant>
      <vt:variant>
        <vt:lpstr>投影片標題</vt:lpstr>
      </vt:variant>
      <vt:variant>
        <vt:i4>4</vt:i4>
      </vt:variant>
    </vt:vector>
  </HeadingPairs>
  <TitlesOfParts>
    <vt:vector size="10" baseType="lpstr">
      <vt:lpstr>新細明體</vt:lpstr>
      <vt:lpstr>Arial</vt:lpstr>
      <vt:lpstr>Calibri</vt:lpstr>
      <vt:lpstr>Calibri Light</vt:lpstr>
      <vt:lpstr>Times New Roman</vt:lpstr>
      <vt:lpstr>Office 佈景主題</vt:lpstr>
      <vt:lpstr>PowerPoint 簡報</vt:lpstr>
      <vt:lpstr>HLA</vt:lpstr>
      <vt:lpstr>GTLA4</vt:lpstr>
      <vt:lpstr>TSHR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yperthyroidism_ GWAS_revise</dc:title>
  <dc:creator>Ting-Yuan Liu</dc:creator>
  <cp:lastModifiedBy>Microsoft 帳戶</cp:lastModifiedBy>
  <cp:revision>3</cp:revision>
  <dcterms:created xsi:type="dcterms:W3CDTF">2022-01-20T00:28:13Z</dcterms:created>
  <dcterms:modified xsi:type="dcterms:W3CDTF">2022-02-11T03:38:04Z</dcterms:modified>
</cp:coreProperties>
</file>